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60" r:id="rId4"/>
    <p:sldId id="262" r:id="rId5"/>
    <p:sldId id="263" r:id="rId6"/>
    <p:sldId id="264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-67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ABC543-0118-B123-809E-AF8D0688B4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431A8EC-A9D2-E8AC-D75E-539048C08E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627C99-5715-C580-2192-042FCF36C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E340E3-E288-0F2A-DCF2-01E69D4F5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A05BFE-B5DC-C300-11D7-F47F1703D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7186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1C97D7-2A45-0D73-C76F-5E670E974E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D1C3AC3-52B6-AC99-8B6A-45A13F54D2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930D32-0671-B3C4-82C6-7B381AB1B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C48F80-D55A-7037-A0D0-A0F39956E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24E967-17A5-6CCA-1C96-3EB95A5A8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4155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0DD6D0E-2E1F-5675-864D-57B0A94190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6720E20-DB73-2166-AE02-922DFF4797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E81103C-2FE5-91F9-04F0-0B3786819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EB339E-1AED-BA87-A011-E417EE5C8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D81226A-915F-BC10-5FD1-8D209C1F5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1892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BF2175-973C-4F73-6DF9-9BD88065B5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4524CF-E9D2-D632-15D3-1D47103C6A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97BB67-E8A4-62FC-9D94-7F1738FE8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08273A-46AB-353E-7ACD-02E02D878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1CD55C1-6E91-A26C-5C28-D58B7DC06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7009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7BE461-F18D-9D0D-3250-1ED72AE502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799FCA3-478E-1DDC-3938-914C4E417D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08F9E49-89D1-F6F7-A7B6-160354E4E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BB6593-D74C-EECA-C0C6-1332FD5D0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8968AE-8ABE-2B9A-1899-412C9FE3F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394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BF9B37-9D5A-D504-A131-8F2237520E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74AF3B1-9F16-216F-28B9-B2AEB63B92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9C63FF-57DD-94C5-F865-3C2B851C21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0365B0-E6B7-B670-D912-F5C8F5B53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4CB5B70-9C12-2EB7-6A87-F0B86448F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D51BE1F-548C-1D24-689D-658212A4C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9734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9C47E9-70DF-3586-41DF-EB5BB3EAC1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A7E15E1-87A4-11CE-6170-C32E9DC4EE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026D350-605F-977E-070A-08E8797A13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61264F0-B6A2-7A3C-1098-7602E8D6FF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81D4A94-FAF1-5122-6DF3-FA75246FB6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FD50370-36AB-8F24-26B4-53C12DB4A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B614DE2-56B7-422D-470D-5BDBC2A94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F0D46C6-BE94-780B-4419-129DF0653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2301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B1C433-6166-5E9E-2D5E-26CB7E557B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F3E4551-9415-CE51-C31D-0E4024E0C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E32BD8C-80B7-8355-4776-326395648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2948DDB-C48B-35C4-6383-1618570B0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7868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0E60D16-1E1A-2AFF-6BEE-F753423A2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1BDE346-A59E-68E5-E05D-9999F4DAD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28D3FEF-A275-A275-3108-E30B494C3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0108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A020C6-F9C0-8E69-3373-A153035BB0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C864666-B740-ED5F-C165-E96909BC4E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BF7592C-EFD6-9016-C4F5-60A328B56E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3CD6883-C659-0823-8091-07BDF74E8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24AE9DE-A4D0-ADFB-5FE8-EBA8797102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B034C27-C9AB-6B2A-4AD4-FA6B7D392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1911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32F759-CA88-CD85-C475-49AA65E3A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2D163C1-8BFB-F920-151C-BD0A9904C0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A3FD242-DDC9-A580-9B5E-D716B60F48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1189AED-486A-E27B-3AA2-416C9A0CF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B460607-DF38-FBD6-75C5-6BF23ACC3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2E4AD08-1872-2C0C-5F3A-00F2A8C29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3633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A98CC1F-CB2A-7F9F-0667-69563346C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DBF8D17-BE5B-8887-7595-771095D959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77BE95-5094-1D33-572A-3F4D559440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4FD9F-76C9-4E81-8B57-D095CC9CE8E1}" type="datetimeFigureOut">
              <a:rPr lang="zh-CN" altLang="en-US" smtClean="0"/>
              <a:t>2026-03-0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779008-8B53-897E-76CA-8CDAD14778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CDE5D3-F016-86A0-7E33-FABB45E929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09DA7C-0F24-48EC-9DA5-3C70386AF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2904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B4167C-8015-4B6C-3D4F-FD316DFE48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23EFDAE-F5B8-C58E-DF51-07F62766D3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8148">
            <a:off x="0" y="0"/>
            <a:ext cx="8379229" cy="6858000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B4662A59-0F86-2689-9D6B-7CCE806640D4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9B4FC3B-1704-7B96-9695-7D3B70E1DFE6}"/>
              </a:ext>
            </a:extLst>
          </p:cNvPr>
          <p:cNvSpPr txBox="1"/>
          <p:nvPr/>
        </p:nvSpPr>
        <p:spPr>
          <a:xfrm rot="19189580">
            <a:off x="4197610" y="2142700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2834037-06C9-3E48-B0DC-9E57C0BF4572}"/>
              </a:ext>
            </a:extLst>
          </p:cNvPr>
          <p:cNvSpPr txBox="1"/>
          <p:nvPr/>
        </p:nvSpPr>
        <p:spPr>
          <a:xfrm rot="19189580">
            <a:off x="4683518" y="2237838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A3D7306-69A9-7AEF-EBD4-66A028255A6B}"/>
              </a:ext>
            </a:extLst>
          </p:cNvPr>
          <p:cNvCxnSpPr>
            <a:cxnSpLocks/>
          </p:cNvCxnSpPr>
          <p:nvPr/>
        </p:nvCxnSpPr>
        <p:spPr>
          <a:xfrm>
            <a:off x="6467145" y="3520203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EB8B5D2-9976-1DC7-2AC4-67CB6F995324}"/>
              </a:ext>
            </a:extLst>
          </p:cNvPr>
          <p:cNvSpPr txBox="1"/>
          <p:nvPr/>
        </p:nvSpPr>
        <p:spPr>
          <a:xfrm>
            <a:off x="246185" y="246185"/>
            <a:ext cx="1245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TDP-43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153A2FF-738E-723E-CBD4-D15EBA4EB20B}"/>
              </a:ext>
            </a:extLst>
          </p:cNvPr>
          <p:cNvSpPr txBox="1"/>
          <p:nvPr/>
        </p:nvSpPr>
        <p:spPr>
          <a:xfrm>
            <a:off x="6574412" y="335314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40</a:t>
            </a:r>
            <a:endParaRPr lang="zh-CN" altLang="en-US" sz="1600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1FB06DF3-1994-4341-E34C-115AE58FD91B}"/>
              </a:ext>
            </a:extLst>
          </p:cNvPr>
          <p:cNvCxnSpPr>
            <a:cxnSpLocks/>
          </p:cNvCxnSpPr>
          <p:nvPr/>
        </p:nvCxnSpPr>
        <p:spPr>
          <a:xfrm>
            <a:off x="6467145" y="3186447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EC731292-E243-9AFA-9210-11EEF68C906A}"/>
              </a:ext>
            </a:extLst>
          </p:cNvPr>
          <p:cNvSpPr txBox="1"/>
          <p:nvPr/>
        </p:nvSpPr>
        <p:spPr>
          <a:xfrm>
            <a:off x="6574412" y="301939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50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D75B70B6-7833-7F46-3817-39551BC88BCC}"/>
              </a:ext>
            </a:extLst>
          </p:cNvPr>
          <p:cNvSpPr/>
          <p:nvPr/>
        </p:nvSpPr>
        <p:spPr>
          <a:xfrm>
            <a:off x="4206240" y="3154680"/>
            <a:ext cx="2123049" cy="4495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6103323-3FAF-D2F3-3C68-93DB61D268F1}"/>
              </a:ext>
            </a:extLst>
          </p:cNvPr>
          <p:cNvSpPr txBox="1"/>
          <p:nvPr/>
        </p:nvSpPr>
        <p:spPr>
          <a:xfrm rot="19189580">
            <a:off x="5160405" y="2112401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95E3C1F-8779-2A50-0D9B-9EC7FCFE3620}"/>
              </a:ext>
            </a:extLst>
          </p:cNvPr>
          <p:cNvSpPr txBox="1"/>
          <p:nvPr/>
        </p:nvSpPr>
        <p:spPr>
          <a:xfrm rot="19189580">
            <a:off x="5692547" y="2207539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5428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B4167C-8015-4B6C-3D4F-FD316DFE48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99E08BC-DF1F-DF6E-2598-803BA89B2C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8379229" cy="6858000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B4662A59-0F86-2689-9D6B-7CCE806640D4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9B4FC3B-1704-7B96-9695-7D3B70E1DFE6}"/>
              </a:ext>
            </a:extLst>
          </p:cNvPr>
          <p:cNvSpPr txBox="1"/>
          <p:nvPr/>
        </p:nvSpPr>
        <p:spPr>
          <a:xfrm rot="19189580">
            <a:off x="3013583" y="2142700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2834037-06C9-3E48-B0DC-9E57C0BF4572}"/>
              </a:ext>
            </a:extLst>
          </p:cNvPr>
          <p:cNvSpPr txBox="1"/>
          <p:nvPr/>
        </p:nvSpPr>
        <p:spPr>
          <a:xfrm rot="19189580">
            <a:off x="3499491" y="2237838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A3D7306-69A9-7AEF-EBD4-66A028255A6B}"/>
              </a:ext>
            </a:extLst>
          </p:cNvPr>
          <p:cNvCxnSpPr>
            <a:cxnSpLocks/>
          </p:cNvCxnSpPr>
          <p:nvPr/>
        </p:nvCxnSpPr>
        <p:spPr>
          <a:xfrm>
            <a:off x="5330007" y="346295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EB8B5D2-9976-1DC7-2AC4-67CB6F995324}"/>
              </a:ext>
            </a:extLst>
          </p:cNvPr>
          <p:cNvSpPr txBox="1"/>
          <p:nvPr/>
        </p:nvSpPr>
        <p:spPr>
          <a:xfrm>
            <a:off x="246185" y="246185"/>
            <a:ext cx="9188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-KIT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153A2FF-738E-723E-CBD4-D15EBA4EB20B}"/>
              </a:ext>
            </a:extLst>
          </p:cNvPr>
          <p:cNvSpPr txBox="1"/>
          <p:nvPr/>
        </p:nvSpPr>
        <p:spPr>
          <a:xfrm>
            <a:off x="5437274" y="329590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70</a:t>
            </a:r>
            <a:endParaRPr lang="zh-CN" altLang="en-US" sz="1600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1FB06DF3-1994-4341-E34C-115AE58FD91B}"/>
              </a:ext>
            </a:extLst>
          </p:cNvPr>
          <p:cNvCxnSpPr>
            <a:cxnSpLocks/>
          </p:cNvCxnSpPr>
          <p:nvPr/>
        </p:nvCxnSpPr>
        <p:spPr>
          <a:xfrm>
            <a:off x="5330007" y="3233339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EC731292-E243-9AFA-9210-11EEF68C906A}"/>
              </a:ext>
            </a:extLst>
          </p:cNvPr>
          <p:cNvSpPr txBox="1"/>
          <p:nvPr/>
        </p:nvSpPr>
        <p:spPr>
          <a:xfrm>
            <a:off x="5437274" y="3066285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100</a:t>
            </a:r>
            <a:endParaRPr lang="zh-CN" altLang="en-US" sz="1600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8CA37004-96E3-DAAC-64F5-E3B1EF705EBE}"/>
              </a:ext>
            </a:extLst>
          </p:cNvPr>
          <p:cNvCxnSpPr>
            <a:cxnSpLocks/>
          </p:cNvCxnSpPr>
          <p:nvPr/>
        </p:nvCxnSpPr>
        <p:spPr>
          <a:xfrm>
            <a:off x="5330007" y="298797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14B17E8F-E70D-F0D8-56EE-2740E7B1B8C4}"/>
              </a:ext>
            </a:extLst>
          </p:cNvPr>
          <p:cNvSpPr txBox="1"/>
          <p:nvPr/>
        </p:nvSpPr>
        <p:spPr>
          <a:xfrm>
            <a:off x="5437274" y="282092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150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D75B70B6-7833-7F46-3817-39551BC88BCC}"/>
              </a:ext>
            </a:extLst>
          </p:cNvPr>
          <p:cNvSpPr/>
          <p:nvPr/>
        </p:nvSpPr>
        <p:spPr>
          <a:xfrm>
            <a:off x="2994660" y="2811780"/>
            <a:ext cx="2080260" cy="3505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6103323-3FAF-D2F3-3C68-93DB61D268F1}"/>
              </a:ext>
            </a:extLst>
          </p:cNvPr>
          <p:cNvSpPr txBox="1"/>
          <p:nvPr/>
        </p:nvSpPr>
        <p:spPr>
          <a:xfrm rot="19189580">
            <a:off x="3976378" y="2112401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95E3C1F-8779-2A50-0D9B-9EC7FCFE3620}"/>
              </a:ext>
            </a:extLst>
          </p:cNvPr>
          <p:cNvSpPr txBox="1"/>
          <p:nvPr/>
        </p:nvSpPr>
        <p:spPr>
          <a:xfrm rot="19189580">
            <a:off x="4508520" y="2207539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29283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B4167C-8015-4B6C-3D4F-FD316DFE48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63EC651-44F9-3579-8F86-D5A169AA5E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8379229" cy="6858000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B4662A59-0F86-2689-9D6B-7CCE806640D4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9B4FC3B-1704-7B96-9695-7D3B70E1DFE6}"/>
              </a:ext>
            </a:extLst>
          </p:cNvPr>
          <p:cNvSpPr txBox="1"/>
          <p:nvPr/>
        </p:nvSpPr>
        <p:spPr>
          <a:xfrm rot="19189580">
            <a:off x="3013583" y="2881249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2834037-06C9-3E48-B0DC-9E57C0BF4572}"/>
              </a:ext>
            </a:extLst>
          </p:cNvPr>
          <p:cNvSpPr txBox="1"/>
          <p:nvPr/>
        </p:nvSpPr>
        <p:spPr>
          <a:xfrm rot="19189580">
            <a:off x="3499491" y="2976387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A3D7306-69A9-7AEF-EBD4-66A028255A6B}"/>
              </a:ext>
            </a:extLst>
          </p:cNvPr>
          <p:cNvCxnSpPr>
            <a:cxnSpLocks/>
          </p:cNvCxnSpPr>
          <p:nvPr/>
        </p:nvCxnSpPr>
        <p:spPr>
          <a:xfrm>
            <a:off x="5116647" y="384395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EB8B5D2-9976-1DC7-2AC4-67CB6F995324}"/>
              </a:ext>
            </a:extLst>
          </p:cNvPr>
          <p:cNvSpPr txBox="1"/>
          <p:nvPr/>
        </p:nvSpPr>
        <p:spPr>
          <a:xfrm>
            <a:off x="246185" y="246185"/>
            <a:ext cx="11945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RUFY1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153A2FF-738E-723E-CBD4-D15EBA4EB20B}"/>
              </a:ext>
            </a:extLst>
          </p:cNvPr>
          <p:cNvSpPr txBox="1"/>
          <p:nvPr/>
        </p:nvSpPr>
        <p:spPr>
          <a:xfrm>
            <a:off x="5223914" y="367690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70</a:t>
            </a:r>
            <a:endParaRPr lang="zh-CN" altLang="en-US" sz="1600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1FB06DF3-1994-4341-E34C-115AE58FD91B}"/>
              </a:ext>
            </a:extLst>
          </p:cNvPr>
          <p:cNvCxnSpPr>
            <a:cxnSpLocks/>
          </p:cNvCxnSpPr>
          <p:nvPr/>
        </p:nvCxnSpPr>
        <p:spPr>
          <a:xfrm>
            <a:off x="5116647" y="3629579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EC731292-E243-9AFA-9210-11EEF68C906A}"/>
              </a:ext>
            </a:extLst>
          </p:cNvPr>
          <p:cNvSpPr txBox="1"/>
          <p:nvPr/>
        </p:nvSpPr>
        <p:spPr>
          <a:xfrm>
            <a:off x="5223914" y="3462525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100</a:t>
            </a:r>
            <a:endParaRPr lang="zh-CN" altLang="en-US" sz="1600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8CA37004-96E3-DAAC-64F5-E3B1EF705EBE}"/>
              </a:ext>
            </a:extLst>
          </p:cNvPr>
          <p:cNvCxnSpPr>
            <a:cxnSpLocks/>
          </p:cNvCxnSpPr>
          <p:nvPr/>
        </p:nvCxnSpPr>
        <p:spPr>
          <a:xfrm>
            <a:off x="5116647" y="416145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14B17E8F-E70D-F0D8-56EE-2740E7B1B8C4}"/>
              </a:ext>
            </a:extLst>
          </p:cNvPr>
          <p:cNvSpPr txBox="1"/>
          <p:nvPr/>
        </p:nvSpPr>
        <p:spPr>
          <a:xfrm>
            <a:off x="5223914" y="399440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50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D75B70B6-7833-7F46-3817-39551BC88BCC}"/>
              </a:ext>
            </a:extLst>
          </p:cNvPr>
          <p:cNvSpPr/>
          <p:nvPr/>
        </p:nvSpPr>
        <p:spPr>
          <a:xfrm>
            <a:off x="2956560" y="3543300"/>
            <a:ext cx="2080260" cy="4343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6103323-3FAF-D2F3-3C68-93DB61D268F1}"/>
              </a:ext>
            </a:extLst>
          </p:cNvPr>
          <p:cNvSpPr txBox="1"/>
          <p:nvPr/>
        </p:nvSpPr>
        <p:spPr>
          <a:xfrm rot="19189580">
            <a:off x="3976378" y="2850950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95E3C1F-8779-2A50-0D9B-9EC7FCFE3620}"/>
              </a:ext>
            </a:extLst>
          </p:cNvPr>
          <p:cNvSpPr txBox="1"/>
          <p:nvPr/>
        </p:nvSpPr>
        <p:spPr>
          <a:xfrm rot="19189580">
            <a:off x="4508520" y="2946088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3093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B4167C-8015-4B6C-3D4F-FD316DFE48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310A377-47F8-8BEE-5AE0-069D3D3417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419707">
            <a:off x="-1" y="-1"/>
            <a:ext cx="8393724" cy="6869863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B4662A59-0F86-2689-9D6B-7CCE806640D4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9B4FC3B-1704-7B96-9695-7D3B70E1DFE6}"/>
              </a:ext>
            </a:extLst>
          </p:cNvPr>
          <p:cNvSpPr txBox="1"/>
          <p:nvPr/>
        </p:nvSpPr>
        <p:spPr>
          <a:xfrm rot="19189580">
            <a:off x="3089783" y="2980900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2834037-06C9-3E48-B0DC-9E57C0BF4572}"/>
              </a:ext>
            </a:extLst>
          </p:cNvPr>
          <p:cNvSpPr txBox="1"/>
          <p:nvPr/>
        </p:nvSpPr>
        <p:spPr>
          <a:xfrm rot="19189580">
            <a:off x="3575691" y="3076038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A3D7306-69A9-7AEF-EBD4-66A028255A6B}"/>
              </a:ext>
            </a:extLst>
          </p:cNvPr>
          <p:cNvCxnSpPr>
            <a:cxnSpLocks/>
          </p:cNvCxnSpPr>
          <p:nvPr/>
        </p:nvCxnSpPr>
        <p:spPr>
          <a:xfrm>
            <a:off x="5096327" y="400397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3EB8B5D2-9976-1DC7-2AC4-67CB6F995324}"/>
              </a:ext>
            </a:extLst>
          </p:cNvPr>
          <p:cNvSpPr txBox="1"/>
          <p:nvPr/>
        </p:nvSpPr>
        <p:spPr>
          <a:xfrm>
            <a:off x="246185" y="246185"/>
            <a:ext cx="14863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yclin B1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153A2FF-738E-723E-CBD4-D15EBA4EB20B}"/>
              </a:ext>
            </a:extLst>
          </p:cNvPr>
          <p:cNvSpPr txBox="1"/>
          <p:nvPr/>
        </p:nvSpPr>
        <p:spPr>
          <a:xfrm>
            <a:off x="5203594" y="383692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50</a:t>
            </a:r>
            <a:endParaRPr lang="zh-CN" altLang="en-US" sz="1600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1FB06DF3-1994-4341-E34C-115AE58FD91B}"/>
              </a:ext>
            </a:extLst>
          </p:cNvPr>
          <p:cNvCxnSpPr>
            <a:cxnSpLocks/>
          </p:cNvCxnSpPr>
          <p:nvPr/>
        </p:nvCxnSpPr>
        <p:spPr>
          <a:xfrm>
            <a:off x="5096327" y="3694349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EC731292-E243-9AFA-9210-11EEF68C906A}"/>
              </a:ext>
            </a:extLst>
          </p:cNvPr>
          <p:cNvSpPr txBox="1"/>
          <p:nvPr/>
        </p:nvSpPr>
        <p:spPr>
          <a:xfrm>
            <a:off x="5203594" y="352729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70</a:t>
            </a:r>
            <a:endParaRPr lang="zh-CN" altLang="en-US" sz="1600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8CA37004-96E3-DAAC-64F5-E3B1EF705EBE}"/>
              </a:ext>
            </a:extLst>
          </p:cNvPr>
          <p:cNvCxnSpPr>
            <a:cxnSpLocks/>
          </p:cNvCxnSpPr>
          <p:nvPr/>
        </p:nvCxnSpPr>
        <p:spPr>
          <a:xfrm>
            <a:off x="5096327" y="452721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14B17E8F-E70D-F0D8-56EE-2740E7B1B8C4}"/>
              </a:ext>
            </a:extLst>
          </p:cNvPr>
          <p:cNvSpPr txBox="1"/>
          <p:nvPr/>
        </p:nvSpPr>
        <p:spPr>
          <a:xfrm>
            <a:off x="5203594" y="436016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40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D75B70B6-7833-7F46-3817-39551BC88BCC}"/>
              </a:ext>
            </a:extLst>
          </p:cNvPr>
          <p:cNvSpPr/>
          <p:nvPr/>
        </p:nvSpPr>
        <p:spPr>
          <a:xfrm>
            <a:off x="3072384" y="3665220"/>
            <a:ext cx="1993392" cy="4343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6103323-3FAF-D2F3-3C68-93DB61D268F1}"/>
              </a:ext>
            </a:extLst>
          </p:cNvPr>
          <p:cNvSpPr txBox="1"/>
          <p:nvPr/>
        </p:nvSpPr>
        <p:spPr>
          <a:xfrm rot="19189580">
            <a:off x="4052578" y="2950601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95E3C1F-8779-2A50-0D9B-9EC7FCFE3620}"/>
              </a:ext>
            </a:extLst>
          </p:cNvPr>
          <p:cNvSpPr txBox="1"/>
          <p:nvPr/>
        </p:nvSpPr>
        <p:spPr>
          <a:xfrm rot="19189580">
            <a:off x="4584720" y="3045739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9A20E0D5-C077-AD58-AB96-8289EF1ADA3D}"/>
              </a:ext>
            </a:extLst>
          </p:cNvPr>
          <p:cNvCxnSpPr>
            <a:cxnSpLocks/>
          </p:cNvCxnSpPr>
          <p:nvPr/>
        </p:nvCxnSpPr>
        <p:spPr>
          <a:xfrm>
            <a:off x="5111567" y="474819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C5C44D27-3DEA-1A1C-E933-C5D7BB2A2F03}"/>
              </a:ext>
            </a:extLst>
          </p:cNvPr>
          <p:cNvSpPr txBox="1"/>
          <p:nvPr/>
        </p:nvSpPr>
        <p:spPr>
          <a:xfrm>
            <a:off x="5218834" y="458114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35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8100046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4E33C0C-218E-2042-E6F1-1995DC820DA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5F0CF00-AFF4-16B4-2D30-41D76B1AA3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8379229" cy="6858000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D92891AE-E755-5976-7F3A-0C662C7DFF23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0351457-EA7D-E6F2-76FA-4336B1488D0C}"/>
              </a:ext>
            </a:extLst>
          </p:cNvPr>
          <p:cNvSpPr txBox="1"/>
          <p:nvPr/>
        </p:nvSpPr>
        <p:spPr>
          <a:xfrm rot="19189580">
            <a:off x="3719642" y="2534008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D2916B2-4FDE-F653-07A7-F19C5DE4EF81}"/>
              </a:ext>
            </a:extLst>
          </p:cNvPr>
          <p:cNvSpPr txBox="1"/>
          <p:nvPr/>
        </p:nvSpPr>
        <p:spPr>
          <a:xfrm rot="19189580">
            <a:off x="4205550" y="2629146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776B8416-893D-76FC-EA1B-46A774356DC5}"/>
              </a:ext>
            </a:extLst>
          </p:cNvPr>
          <p:cNvCxnSpPr>
            <a:cxnSpLocks/>
          </p:cNvCxnSpPr>
          <p:nvPr/>
        </p:nvCxnSpPr>
        <p:spPr>
          <a:xfrm>
            <a:off x="5498612" y="382026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B3B14BD1-34C2-10FA-1141-16F422647200}"/>
              </a:ext>
            </a:extLst>
          </p:cNvPr>
          <p:cNvSpPr txBox="1"/>
          <p:nvPr/>
        </p:nvSpPr>
        <p:spPr>
          <a:xfrm>
            <a:off x="246185" y="246185"/>
            <a:ext cx="12282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PSMA7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AF4F772-D65F-77BD-C9D7-3EF021EE8FEF}"/>
              </a:ext>
            </a:extLst>
          </p:cNvPr>
          <p:cNvSpPr txBox="1"/>
          <p:nvPr/>
        </p:nvSpPr>
        <p:spPr>
          <a:xfrm>
            <a:off x="5605879" y="365321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25</a:t>
            </a:r>
            <a:endParaRPr lang="zh-CN" altLang="en-US" sz="1600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CA316674-351A-EA0E-F939-E0E5C958D8B7}"/>
              </a:ext>
            </a:extLst>
          </p:cNvPr>
          <p:cNvCxnSpPr>
            <a:cxnSpLocks/>
          </p:cNvCxnSpPr>
          <p:nvPr/>
        </p:nvCxnSpPr>
        <p:spPr>
          <a:xfrm>
            <a:off x="5498612" y="3447393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A5E9863B-4CF1-C1F6-B44B-3F2A06AF3207}"/>
              </a:ext>
            </a:extLst>
          </p:cNvPr>
          <p:cNvSpPr txBox="1"/>
          <p:nvPr/>
        </p:nvSpPr>
        <p:spPr>
          <a:xfrm>
            <a:off x="5605879" y="328033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35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C77BFAA-3A63-0A2D-1480-A198B7BEFB43}"/>
              </a:ext>
            </a:extLst>
          </p:cNvPr>
          <p:cNvSpPr/>
          <p:nvPr/>
        </p:nvSpPr>
        <p:spPr>
          <a:xfrm>
            <a:off x="3338525" y="3415978"/>
            <a:ext cx="2080260" cy="4343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E2D6CA3-4F77-CA45-AF94-EA5F0693C8A5}"/>
              </a:ext>
            </a:extLst>
          </p:cNvPr>
          <p:cNvSpPr txBox="1"/>
          <p:nvPr/>
        </p:nvSpPr>
        <p:spPr>
          <a:xfrm rot="19189580">
            <a:off x="4682437" y="2503709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BC04753-0869-C002-6CE2-CBC22F777855}"/>
              </a:ext>
            </a:extLst>
          </p:cNvPr>
          <p:cNvSpPr txBox="1"/>
          <p:nvPr/>
        </p:nvSpPr>
        <p:spPr>
          <a:xfrm rot="19189580">
            <a:off x="5214579" y="2598847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11019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C2E8F0E-44E5-BCB8-3111-9007F716167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2ABD940-E243-8766-BF07-28C3B7EBA6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540000">
            <a:off x="-1" y="0"/>
            <a:ext cx="8379229" cy="6858000"/>
          </a:xfrm>
          <a:prstGeom prst="rect">
            <a:avLst/>
          </a:prstGeom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BF5A58F5-1B54-5E70-5B68-B1709CD078EF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A16A124-063D-9183-7BFB-E9A2EF00AE9D}"/>
              </a:ext>
            </a:extLst>
          </p:cNvPr>
          <p:cNvSpPr txBox="1"/>
          <p:nvPr/>
        </p:nvSpPr>
        <p:spPr>
          <a:xfrm rot="19189580">
            <a:off x="3013583" y="2881249"/>
            <a:ext cx="1283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904763E-1CC9-DB9F-FAD9-7A785341A5E9}"/>
              </a:ext>
            </a:extLst>
          </p:cNvPr>
          <p:cNvSpPr txBox="1"/>
          <p:nvPr/>
        </p:nvSpPr>
        <p:spPr>
          <a:xfrm rot="19189580">
            <a:off x="3499491" y="2976387"/>
            <a:ext cx="988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WT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A2B310B5-7226-9249-7716-B3C7B11C57A0}"/>
              </a:ext>
            </a:extLst>
          </p:cNvPr>
          <p:cNvCxnSpPr>
            <a:cxnSpLocks/>
          </p:cNvCxnSpPr>
          <p:nvPr/>
        </p:nvCxnSpPr>
        <p:spPr>
          <a:xfrm>
            <a:off x="5053147" y="374743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7D2BB878-E126-BC63-4CEC-E8D5FCCF4881}"/>
              </a:ext>
            </a:extLst>
          </p:cNvPr>
          <p:cNvSpPr txBox="1"/>
          <p:nvPr/>
        </p:nvSpPr>
        <p:spPr>
          <a:xfrm>
            <a:off x="246185" y="246185"/>
            <a:ext cx="12795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FF4E683-B472-A3A5-B428-30BE76B6227C}"/>
              </a:ext>
            </a:extLst>
          </p:cNvPr>
          <p:cNvSpPr txBox="1"/>
          <p:nvPr/>
        </p:nvSpPr>
        <p:spPr>
          <a:xfrm>
            <a:off x="5160414" y="358038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40</a:t>
            </a:r>
            <a:endParaRPr lang="zh-CN" altLang="en-US" sz="1600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9930CEA5-9411-3645-01DC-D03155014DF6}"/>
              </a:ext>
            </a:extLst>
          </p:cNvPr>
          <p:cNvCxnSpPr>
            <a:cxnSpLocks/>
          </p:cNvCxnSpPr>
          <p:nvPr/>
        </p:nvCxnSpPr>
        <p:spPr>
          <a:xfrm>
            <a:off x="5053147" y="4064935"/>
            <a:ext cx="17891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BF54E191-3FB9-DFB9-4170-28B8B5672172}"/>
              </a:ext>
            </a:extLst>
          </p:cNvPr>
          <p:cNvSpPr txBox="1"/>
          <p:nvPr/>
        </p:nvSpPr>
        <p:spPr>
          <a:xfrm>
            <a:off x="5160414" y="389788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35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5650309A-0C7D-D372-FFAC-FE796A4BE86A}"/>
              </a:ext>
            </a:extLst>
          </p:cNvPr>
          <p:cNvSpPr/>
          <p:nvPr/>
        </p:nvSpPr>
        <p:spPr>
          <a:xfrm>
            <a:off x="3098800" y="3728720"/>
            <a:ext cx="1938020" cy="3403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1FCD58C3-E569-B37C-7A44-08D52593D88A}"/>
              </a:ext>
            </a:extLst>
          </p:cNvPr>
          <p:cNvSpPr txBox="1"/>
          <p:nvPr/>
        </p:nvSpPr>
        <p:spPr>
          <a:xfrm rot="19189580">
            <a:off x="3976378" y="2850950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oocyt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94F47E0-8045-28E4-B864-F2176AAC714A}"/>
              </a:ext>
            </a:extLst>
          </p:cNvPr>
          <p:cNvSpPr txBox="1"/>
          <p:nvPr/>
        </p:nvSpPr>
        <p:spPr>
          <a:xfrm rot="19189580">
            <a:off x="4508520" y="2946088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cKO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eg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7764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161</Words>
  <Application>Microsoft Office PowerPoint</Application>
  <PresentationFormat>宽屏</PresentationFormat>
  <Paragraphs>52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 Rong</dc:creator>
  <cp:lastModifiedBy>yan Rong</cp:lastModifiedBy>
  <cp:revision>10</cp:revision>
  <dcterms:created xsi:type="dcterms:W3CDTF">2026-03-07T08:57:59Z</dcterms:created>
  <dcterms:modified xsi:type="dcterms:W3CDTF">2026-03-07T14:11:20Z</dcterms:modified>
</cp:coreProperties>
</file>